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9" r:id="rId3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4906" userDrawn="1">
          <p15:clr>
            <a:srgbClr val="A4A3A4"/>
          </p15:clr>
        </p15:guide>
        <p15:guide id="2" orient="horz" pos="388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CUServices" initials="RG" lastIdx="1" clrIdx="0">
    <p:extLst>
      <p:ext uri="{19B8F6BF-5375-455C-9EA6-DF929625EA0E}">
        <p15:presenceInfo xmlns:p15="http://schemas.microsoft.com/office/powerpoint/2012/main" userId="ICUServices" providerId="None"/>
      </p:ext>
    </p:extLst>
  </p:cmAuthor>
  <p:cmAuthor id="2" name="YS" initials="Y" lastIdx="1" clrIdx="1">
    <p:extLst>
      <p:ext uri="{19B8F6BF-5375-455C-9EA6-DF929625EA0E}">
        <p15:presenceInfo xmlns:p15="http://schemas.microsoft.com/office/powerpoint/2012/main" userId="YS" providerId="None"/>
      </p:ext>
    </p:extLst>
  </p:cmAuthor>
  <p:cmAuthor id="3" name="ASCA" initials="A" lastIdx="1" clrIdx="2">
    <p:extLst>
      <p:ext uri="{19B8F6BF-5375-455C-9EA6-DF929625EA0E}">
        <p15:presenceInfo xmlns:p15="http://schemas.microsoft.com/office/powerpoint/2012/main" userId="ASCA" providerId="None"/>
      </p:ext>
    </p:extLst>
  </p:cmAuthor>
  <p:cmAuthor id="4" name="Yuka Kinoshita" initials="YK" lastIdx="2" clrIdx="3">
    <p:extLst>
      <p:ext uri="{19B8F6BF-5375-455C-9EA6-DF929625EA0E}">
        <p15:presenceInfo xmlns:p15="http://schemas.microsoft.com/office/powerpoint/2012/main" userId="Yuka Kinoshit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700"/>
    <a:srgbClr val="4180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66B8786-FD68-4E89-A94B-BBF6A75C3E21}" v="4" dt="2026-03-16T12:39:11.22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32" autoAdjust="0"/>
    <p:restoredTop sz="93129" autoAdjust="0"/>
  </p:normalViewPr>
  <p:slideViewPr>
    <p:cSldViewPr snapToGrid="0">
      <p:cViewPr varScale="1">
        <p:scale>
          <a:sx n="55" d="100"/>
          <a:sy n="55" d="100"/>
        </p:scale>
        <p:origin x="1450" y="53"/>
      </p:cViewPr>
      <p:guideLst>
        <p:guide pos="4906"/>
        <p:guide orient="horz" pos="388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commentAuthors" Target="commentAuthors.xml"/><Relationship Id="rId10" Type="http://schemas.microsoft.com/office/2016/11/relationships/changesInfo" Target="changesInfos/changesInfo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橘 尚子" userId="7bab3f16-701f-436c-a1b1-79f2534dce0c" providerId="ADAL" clId="{DF6D4CF4-A34A-468C-B7A7-834842E48B6A}"/>
    <pc:docChg chg="custSel addSld delSld modSld">
      <pc:chgData name="橘 尚子" userId="7bab3f16-701f-436c-a1b1-79f2534dce0c" providerId="ADAL" clId="{DF6D4CF4-A34A-468C-B7A7-834842E48B6A}" dt="2026-03-16T12:39:39.052" v="43" actId="1076"/>
      <pc:docMkLst>
        <pc:docMk/>
      </pc:docMkLst>
      <pc:sldChg chg="addSp modSp mod">
        <pc:chgData name="橘 尚子" userId="7bab3f16-701f-436c-a1b1-79f2534dce0c" providerId="ADAL" clId="{DF6D4CF4-A34A-468C-B7A7-834842E48B6A}" dt="2026-03-16T12:39:39.052" v="43" actId="1076"/>
        <pc:sldMkLst>
          <pc:docMk/>
          <pc:sldMk cId="55276188" sldId="257"/>
        </pc:sldMkLst>
        <pc:spChg chg="add mod">
          <ac:chgData name="橘 尚子" userId="7bab3f16-701f-436c-a1b1-79f2534dce0c" providerId="ADAL" clId="{DF6D4CF4-A34A-468C-B7A7-834842E48B6A}" dt="2026-03-16T12:39:39.052" v="43" actId="1076"/>
          <ac:spMkLst>
            <pc:docMk/>
            <pc:sldMk cId="55276188" sldId="257"/>
            <ac:spMk id="2" creationId="{409B12BA-1A55-876B-B80C-1CF0235E15B5}"/>
          </ac:spMkLst>
        </pc:spChg>
      </pc:sldChg>
      <pc:sldChg chg="addSp delSp modSp new mod">
        <pc:chgData name="橘 尚子" userId="7bab3f16-701f-436c-a1b1-79f2534dce0c" providerId="ADAL" clId="{DF6D4CF4-A34A-468C-B7A7-834842E48B6A}" dt="2026-03-16T12:39:29.475" v="41" actId="1076"/>
        <pc:sldMkLst>
          <pc:docMk/>
          <pc:sldMk cId="1221755540" sldId="259"/>
        </pc:sldMkLst>
        <pc:spChg chg="add mod">
          <ac:chgData name="橘 尚子" userId="7bab3f16-701f-436c-a1b1-79f2534dce0c" providerId="ADAL" clId="{DF6D4CF4-A34A-468C-B7A7-834842E48B6A}" dt="2026-03-16T12:39:29.475" v="41" actId="1076"/>
          <ac:spMkLst>
            <pc:docMk/>
            <pc:sldMk cId="1221755540" sldId="259"/>
            <ac:spMk id="2" creationId="{CE04A2B8-C61E-CD93-6E72-6C2404A0C812}"/>
          </ac:spMkLst>
        </pc:spChg>
        <pc:picChg chg="add mod">
          <ac:chgData name="橘 尚子" userId="7bab3f16-701f-436c-a1b1-79f2534dce0c" providerId="ADAL" clId="{DF6D4CF4-A34A-468C-B7A7-834842E48B6A}" dt="2026-02-24T10:21:33.599" v="15" actId="1076"/>
          <ac:picMkLst>
            <pc:docMk/>
            <pc:sldMk cId="1221755540" sldId="259"/>
            <ac:picMk id="3" creationId="{5F025DF9-CFFA-445F-E577-7DE7B3D24109}"/>
          </ac:picMkLst>
        </pc:picChg>
        <pc:picChg chg="add mod">
          <ac:chgData name="橘 尚子" userId="7bab3f16-701f-436c-a1b1-79f2534dce0c" providerId="ADAL" clId="{DF6D4CF4-A34A-468C-B7A7-834842E48B6A}" dt="2026-02-24T10:21:15.178" v="13" actId="1076"/>
          <ac:picMkLst>
            <pc:docMk/>
            <pc:sldMk cId="1221755540" sldId="259"/>
            <ac:picMk id="5" creationId="{E9F1E96B-AF6D-7784-6E20-736E41594965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1AC234-C0EE-4E07-A6E5-6CB21801510F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B69316-E3F5-4108-9E5B-6C910229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4046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B69316-E3F5-4108-9E5B-6C910229EAF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2453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A8C5FD-C5EE-4DA6-ED7D-F0011CF2EC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57549D6-5E5C-16CD-6538-2BB174D764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CA84852-A5A7-6280-A162-F69F9A760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9C976-0FDE-4623-9F58-42A8CC65CD12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1A6209D-6930-B188-6229-C11998F44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98C378-EC9B-2ABC-7EC5-58E5B8A513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3A3A-AF2D-408B-97A0-F8578FD2C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4938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F68896-8A5A-0ED2-4DC3-7B927836D6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8A2B482-4F17-7D3B-B1E3-35C407288B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B7129D-56B8-94EC-56D6-F0F04E68FE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9C976-0FDE-4623-9F58-42A8CC65CD12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286518-CFF4-B7CC-CE94-70DBB23E64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B1FAF9B-9D70-5112-C3C0-D7E307F95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3A3A-AF2D-408B-97A0-F8578FD2C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260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F153246-7D15-3F09-6F53-BD4E27CB51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C10B572-9235-2EF0-1B74-D9BAB7153E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9BFEF44-DBB9-6F65-B3C1-E1C9F6E1A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9C976-0FDE-4623-9F58-42A8CC65CD12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D19397-8E20-5737-C748-899317F7B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C12590E-176E-095F-00B6-C44A058D7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3A3A-AF2D-408B-97A0-F8578FD2C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183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6C5B7A-7238-A5BF-83C6-5DEC666878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EF8E240-EDE7-A617-3CE3-A101A4D43C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032107-9396-02F4-C0C3-4F025DEA03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9C976-0FDE-4623-9F58-42A8CC65CD12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5C876C-3455-DF98-550A-FA3535EBAB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745BD45-9F49-23B0-ECF6-3FC2265CD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3A3A-AF2D-408B-97A0-F8578FD2C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165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D4EA36-D35E-CAB8-41EB-4807EC16CA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4321739-98C7-892F-8D73-7524EEBD78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EAD9899-0D7F-1AC1-63BC-14E99AE00F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9C976-0FDE-4623-9F58-42A8CC65CD12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AA3F7A7-D252-DF12-1F3C-198027F6E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9413311-9392-B145-C542-C369B15D24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3A3A-AF2D-408B-97A0-F8578FD2C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43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E9CE5D-D17C-36D8-DA87-260967CEAD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67B2CED-901E-43D4-DCCD-34291DEC06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4B4A3D9-A43F-3F59-61B5-546D2CE175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FA80208-37FA-FC16-B8E2-43C0A9775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9C976-0FDE-4623-9F58-42A8CC65CD12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7A8D142-FF5B-EEB7-7304-5F4EBE4E3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F3583C3-5B1A-361B-0BA3-E6289863D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3A3A-AF2D-408B-97A0-F8578FD2C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03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073BA3-0CAE-CB78-1721-3B6B3E9581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9ED8886-C6B3-7A21-B707-850D739687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DD92506-F0E8-F20B-00C8-85A7A65DBD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C0E5A81-506F-12C6-E1D6-EBD34C7FB5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CED0A1B-0749-C310-649A-4B9E284128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6EFAFD6-F3B6-3846-4215-DAFA2200A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9C976-0FDE-4623-9F58-42A8CC65CD12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5510B94-4563-9AE0-8CBB-16D8A2C3E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EA27BB1-47BC-E8E2-8224-04D88202CE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3A3A-AF2D-408B-97A0-F8578FD2C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596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820E30-C00D-0870-204E-EBE779D5F3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FC63649-AABD-8725-CEB1-B0D8C96FFD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9C976-0FDE-4623-9F58-42A8CC65CD12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078A7B2-3EBD-C4A6-8356-4D9092773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B6FBD26-1C1E-6C1A-B1AD-D7F54E447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3A3A-AF2D-408B-97A0-F8578FD2C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615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85235BF-8B50-4C2C-81BF-0126BB086B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9C976-0FDE-4623-9F58-42A8CC65CD12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1C29DB5-0F11-20F7-77C8-A82AA025A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D403193-6E30-9850-567F-37A419C46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3A3A-AF2D-408B-97A0-F8578FD2C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618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F1113A-41CD-983A-056B-4511B4A581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2F83AB1-AFDF-1FB8-5FD4-EFB8AFA88B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DD01B0A-342A-2533-D105-135D818EFD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10FB118-9F31-3C14-2B66-D4FAC3DFEC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9C976-0FDE-4623-9F58-42A8CC65CD12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742EB82-361E-E869-A2EF-DC6A3A4DE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2C78ABC-AE27-E923-E9FF-C39F1E8E3F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3A3A-AF2D-408B-97A0-F8578FD2C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7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D6F3FC-B873-196F-FC65-30B447F914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74A7E53-B694-831C-3268-8F5A020C9B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88D9D06-5ECB-C1BC-1C39-C8E43CCAD0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6D7A4C2-6355-4BA5-961F-FFE60B330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E9C976-0FDE-4623-9F58-42A8CC65CD12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746163B-F762-BEB3-C80B-4C9839BF0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64D04C1-D24F-EF2D-FE1A-5A946BDB0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63A3A-AF2D-408B-97A0-F8578FD2C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260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350A3DB-4083-0D8C-9F80-6066A5AEA5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E65B405-0021-EA6E-C71E-2B985B1501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681ECF9-8236-DB78-9874-10DC524A97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E9C976-0FDE-4623-9F58-42A8CC65CD12}" type="datetimeFigureOut">
              <a:rPr lang="en-US" smtClean="0"/>
              <a:t>3/16/2026</a:t>
            </a:fld>
            <a:endParaRPr 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FFA480-B4B8-6458-C11D-7AFCCC69BDA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B38C16A-F18C-DF3E-AE78-5042001EE7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063A3A-AF2D-408B-97A0-F8578FD2C0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881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2D26008-E500-0D99-3B54-F4532A89BDA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C7ECF4D-1BAB-8F74-1429-DA3A2491F36C}"/>
              </a:ext>
            </a:extLst>
          </p:cNvPr>
          <p:cNvSpPr txBox="1"/>
          <p:nvPr/>
        </p:nvSpPr>
        <p:spPr>
          <a:xfrm>
            <a:off x="425506" y="512780"/>
            <a:ext cx="197344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876 patients enrolled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F6394F6-0FF2-4201-E60E-45134C8F8813}"/>
              </a:ext>
            </a:extLst>
          </p:cNvPr>
          <p:cNvSpPr txBox="1"/>
          <p:nvPr/>
        </p:nvSpPr>
        <p:spPr>
          <a:xfrm>
            <a:off x="425506" y="2198556"/>
            <a:ext cx="197344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844 first CRFs collected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C62856C-4266-A880-866D-D450F5077A38}"/>
              </a:ext>
            </a:extLst>
          </p:cNvPr>
          <p:cNvSpPr txBox="1"/>
          <p:nvPr/>
        </p:nvSpPr>
        <p:spPr>
          <a:xfrm>
            <a:off x="425508" y="3281533"/>
            <a:ext cx="197343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809 first CRFs fixed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5893BAB-C370-3526-F090-79361D58AC30}"/>
              </a:ext>
            </a:extLst>
          </p:cNvPr>
          <p:cNvSpPr txBox="1"/>
          <p:nvPr/>
        </p:nvSpPr>
        <p:spPr>
          <a:xfrm>
            <a:off x="425505" y="4182599"/>
            <a:ext cx="2897923" cy="7848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638 patients for safety analysis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4-week treatment</a:t>
            </a: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(including 105 patients with schizophrenia and 129 patients with depression)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630A944-E446-A369-8676-3936947F831D}"/>
              </a:ext>
            </a:extLst>
          </p:cNvPr>
          <p:cNvSpPr txBox="1"/>
          <p:nvPr/>
        </p:nvSpPr>
        <p:spPr>
          <a:xfrm>
            <a:off x="425507" y="5632152"/>
            <a:ext cx="2897924" cy="7848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410 patients for effectiveness analysis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4-week treatment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including 100 patients with schizophrenia and 120 patients with depression)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F994CC0-191C-5C83-AB64-2E84011948E4}"/>
              </a:ext>
            </a:extLst>
          </p:cNvPr>
          <p:cNvSpPr txBox="1"/>
          <p:nvPr/>
        </p:nvSpPr>
        <p:spPr>
          <a:xfrm>
            <a:off x="6350873" y="2847399"/>
            <a:ext cx="216917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30 second CRFs collected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4FD0ACB-1416-2358-316B-AE99BF5C5FE8}"/>
              </a:ext>
            </a:extLst>
          </p:cNvPr>
          <p:cNvSpPr txBox="1"/>
          <p:nvPr/>
        </p:nvSpPr>
        <p:spPr>
          <a:xfrm>
            <a:off x="6350873" y="3714095"/>
            <a:ext cx="216916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15 second CRFs fixed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0083396-E8BB-89BF-8642-26C5E4B46472}"/>
              </a:ext>
            </a:extLst>
          </p:cNvPr>
          <p:cNvSpPr txBox="1"/>
          <p:nvPr/>
        </p:nvSpPr>
        <p:spPr>
          <a:xfrm>
            <a:off x="6350862" y="4328917"/>
            <a:ext cx="2897922" cy="7848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15 patients for safety analysis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52-week treatment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including 43 patients with schizophrenia and 55 patients with depression)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9E64958-C992-8A52-A66E-AAB0752301C1}"/>
              </a:ext>
            </a:extLst>
          </p:cNvPr>
          <p:cNvSpPr txBox="1"/>
          <p:nvPr/>
        </p:nvSpPr>
        <p:spPr>
          <a:xfrm>
            <a:off x="6350872" y="5632152"/>
            <a:ext cx="2897923" cy="7848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215 patients for effectiveness analysis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52-week treatment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including 42 patients with schizophrenia and 51 patients with depression)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C722ABC-5883-5CA7-2BC2-EF8A9A29F6A4}"/>
              </a:ext>
            </a:extLst>
          </p:cNvPr>
          <p:cNvSpPr txBox="1"/>
          <p:nvPr/>
        </p:nvSpPr>
        <p:spPr>
          <a:xfrm>
            <a:off x="6350873" y="1980703"/>
            <a:ext cx="216918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48 second CRFs provided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77EAC67-BA18-738F-AB60-8BA7F5431EAC}"/>
              </a:ext>
            </a:extLst>
          </p:cNvPr>
          <p:cNvSpPr txBox="1"/>
          <p:nvPr/>
        </p:nvSpPr>
        <p:spPr>
          <a:xfrm>
            <a:off x="3541856" y="1596034"/>
            <a:ext cx="1741344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2 CRFs not collected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93A91E2-EEC8-B8D3-D0BD-7AF60EEE6D63}"/>
              </a:ext>
            </a:extLst>
          </p:cNvPr>
          <p:cNvSpPr txBox="1"/>
          <p:nvPr/>
        </p:nvSpPr>
        <p:spPr>
          <a:xfrm>
            <a:off x="3541856" y="2678273"/>
            <a:ext cx="162179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 CRFs not fixed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67D129A-1895-3A8A-01E0-90F20072FC51}"/>
              </a:ext>
            </a:extLst>
          </p:cNvPr>
          <p:cNvSpPr txBox="1"/>
          <p:nvPr/>
        </p:nvSpPr>
        <p:spPr>
          <a:xfrm>
            <a:off x="3519658" y="3281554"/>
            <a:ext cx="2520000" cy="13849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71 patients excluded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● 167 no visit after the initial visit      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● 1 no treatment with elobixibat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● 1 treatment before registration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● 1 enrollment in duplicate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● 1 enrollment ≥15 days after the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initial treatment  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34F4C6D-5C4F-C5EC-03E3-DD5C19DA3D1E}"/>
              </a:ext>
            </a:extLst>
          </p:cNvPr>
          <p:cNvSpPr txBox="1"/>
          <p:nvPr/>
        </p:nvSpPr>
        <p:spPr>
          <a:xfrm>
            <a:off x="3524588" y="4967429"/>
            <a:ext cx="2520000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28 patients excluded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● 55 lacking effectiveness data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● 10 inappropriate data handli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● 163 off-label drug use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40E0820-C314-1399-D010-BF4335DD4E57}"/>
              </a:ext>
            </a:extLst>
          </p:cNvPr>
          <p:cNvSpPr txBox="1"/>
          <p:nvPr/>
        </p:nvSpPr>
        <p:spPr>
          <a:xfrm>
            <a:off x="9452264" y="2401274"/>
            <a:ext cx="1690534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8 CRFs not collected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D809DE3-9E74-ED4D-DA22-A0B257238436}"/>
              </a:ext>
            </a:extLst>
          </p:cNvPr>
          <p:cNvSpPr txBox="1"/>
          <p:nvPr/>
        </p:nvSpPr>
        <p:spPr>
          <a:xfrm>
            <a:off x="9452263" y="3269049"/>
            <a:ext cx="169053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 CRFs not fixed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E2E4935-E5E9-29E2-06AD-FF80D7CF8E2C}"/>
              </a:ext>
            </a:extLst>
          </p:cNvPr>
          <p:cNvSpPr txBox="1"/>
          <p:nvPr/>
        </p:nvSpPr>
        <p:spPr>
          <a:xfrm>
            <a:off x="9494758" y="4981107"/>
            <a:ext cx="2520000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 patients excluded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● 1 lacking effectiveness data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● 10 inappropriate data handli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● 89 off-label drug use</a:t>
            </a:r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0C62E5F6-9CA1-16D5-E6E2-A72953E03801}"/>
              </a:ext>
            </a:extLst>
          </p:cNvPr>
          <p:cNvCxnSpPr>
            <a:cxnSpLocks/>
          </p:cNvCxnSpPr>
          <p:nvPr/>
        </p:nvCxnSpPr>
        <p:spPr>
          <a:xfrm>
            <a:off x="1823045" y="789779"/>
            <a:ext cx="0" cy="140877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B1B48B9D-5114-821D-7E51-1E4784794C55}"/>
              </a:ext>
            </a:extLst>
          </p:cNvPr>
          <p:cNvCxnSpPr>
            <a:cxnSpLocks/>
          </p:cNvCxnSpPr>
          <p:nvPr/>
        </p:nvCxnSpPr>
        <p:spPr>
          <a:xfrm>
            <a:off x="1814602" y="2475555"/>
            <a:ext cx="2" cy="80597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AA343B4D-E094-9A0D-4E38-CD25E43387AF}"/>
              </a:ext>
            </a:extLst>
          </p:cNvPr>
          <p:cNvCxnSpPr>
            <a:cxnSpLocks/>
          </p:cNvCxnSpPr>
          <p:nvPr/>
        </p:nvCxnSpPr>
        <p:spPr>
          <a:xfrm>
            <a:off x="1812285" y="3546048"/>
            <a:ext cx="0" cy="63655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9C1A155E-EC5C-A3D3-2B7D-CF43B8B9BAA5}"/>
              </a:ext>
            </a:extLst>
          </p:cNvPr>
          <p:cNvCxnSpPr>
            <a:cxnSpLocks/>
          </p:cNvCxnSpPr>
          <p:nvPr/>
        </p:nvCxnSpPr>
        <p:spPr>
          <a:xfrm>
            <a:off x="1813920" y="4981107"/>
            <a:ext cx="9123" cy="66353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67974DDB-D176-65E6-5032-4626C04E67D9}"/>
              </a:ext>
            </a:extLst>
          </p:cNvPr>
          <p:cNvCxnSpPr>
            <a:cxnSpLocks/>
            <a:endCxn id="14" idx="1"/>
          </p:cNvCxnSpPr>
          <p:nvPr/>
        </p:nvCxnSpPr>
        <p:spPr>
          <a:xfrm>
            <a:off x="1811338" y="1733776"/>
            <a:ext cx="1730518" cy="758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コネクタ: カギ線 35">
            <a:extLst>
              <a:ext uri="{FF2B5EF4-FFF2-40B4-BE49-F238E27FC236}">
                <a16:creationId xmlns:a16="http://schemas.microsoft.com/office/drawing/2014/main" id="{3ABEDBE8-E558-0C53-6C6E-95C16BD07913}"/>
              </a:ext>
            </a:extLst>
          </p:cNvPr>
          <p:cNvCxnSpPr>
            <a:cxnSpLocks/>
            <a:stCxn id="4" idx="3"/>
          </p:cNvCxnSpPr>
          <p:nvPr/>
        </p:nvCxnSpPr>
        <p:spPr>
          <a:xfrm>
            <a:off x="2398952" y="651280"/>
            <a:ext cx="5400871" cy="1337641"/>
          </a:xfrm>
          <a:prstGeom prst="bentConnector3">
            <a:avLst>
              <a:gd name="adj1" fmla="val 99995"/>
            </a:avLst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DCFE0C38-EFFC-8800-1F5D-1C8413A9087C}"/>
              </a:ext>
            </a:extLst>
          </p:cNvPr>
          <p:cNvCxnSpPr>
            <a:cxnSpLocks/>
          </p:cNvCxnSpPr>
          <p:nvPr/>
        </p:nvCxnSpPr>
        <p:spPr>
          <a:xfrm>
            <a:off x="7793759" y="2244924"/>
            <a:ext cx="0" cy="58969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9" name="直線矢印コネクタ 38">
            <a:extLst>
              <a:ext uri="{FF2B5EF4-FFF2-40B4-BE49-F238E27FC236}">
                <a16:creationId xmlns:a16="http://schemas.microsoft.com/office/drawing/2014/main" id="{F5A6E60F-B5C9-7AFE-87EC-436AD0B3915F}"/>
              </a:ext>
            </a:extLst>
          </p:cNvPr>
          <p:cNvCxnSpPr/>
          <p:nvPr/>
        </p:nvCxnSpPr>
        <p:spPr>
          <a:xfrm>
            <a:off x="7794669" y="3124398"/>
            <a:ext cx="0" cy="58969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928116B4-D55E-01B0-B3E0-FC4B3663144A}"/>
              </a:ext>
            </a:extLst>
          </p:cNvPr>
          <p:cNvCxnSpPr>
            <a:cxnSpLocks/>
          </p:cNvCxnSpPr>
          <p:nvPr/>
        </p:nvCxnSpPr>
        <p:spPr>
          <a:xfrm>
            <a:off x="7792378" y="3992762"/>
            <a:ext cx="0" cy="33615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5F761B84-10CB-BD8D-DE12-82938B9E0CE8}"/>
              </a:ext>
            </a:extLst>
          </p:cNvPr>
          <p:cNvCxnSpPr>
            <a:cxnSpLocks/>
          </p:cNvCxnSpPr>
          <p:nvPr/>
        </p:nvCxnSpPr>
        <p:spPr>
          <a:xfrm>
            <a:off x="7793759" y="5113747"/>
            <a:ext cx="0" cy="51840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E890ED9B-56BC-2126-CD64-8B05329E2A2E}"/>
              </a:ext>
            </a:extLst>
          </p:cNvPr>
          <p:cNvCxnSpPr>
            <a:cxnSpLocks/>
            <a:endCxn id="18" idx="1"/>
          </p:cNvCxnSpPr>
          <p:nvPr/>
        </p:nvCxnSpPr>
        <p:spPr>
          <a:xfrm>
            <a:off x="7791841" y="2539772"/>
            <a:ext cx="1660423" cy="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79DCC0B0-7838-757C-5FE7-DA0611400DE8}"/>
              </a:ext>
            </a:extLst>
          </p:cNvPr>
          <p:cNvCxnSpPr>
            <a:cxnSpLocks/>
          </p:cNvCxnSpPr>
          <p:nvPr/>
        </p:nvCxnSpPr>
        <p:spPr>
          <a:xfrm>
            <a:off x="7791841" y="3407548"/>
            <a:ext cx="1660422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4E3A6C88-F649-48A0-59DC-D9465A58FF7C}"/>
              </a:ext>
            </a:extLst>
          </p:cNvPr>
          <p:cNvCxnSpPr/>
          <p:nvPr/>
        </p:nvCxnSpPr>
        <p:spPr>
          <a:xfrm flipV="1">
            <a:off x="7791841" y="5337304"/>
            <a:ext cx="1702917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6" name="直線矢印コネクタ 45">
            <a:extLst>
              <a:ext uri="{FF2B5EF4-FFF2-40B4-BE49-F238E27FC236}">
                <a16:creationId xmlns:a16="http://schemas.microsoft.com/office/drawing/2014/main" id="{F40E2AC2-D5E7-78E2-D4EC-08E916ADFCD8}"/>
              </a:ext>
            </a:extLst>
          </p:cNvPr>
          <p:cNvCxnSpPr>
            <a:cxnSpLocks/>
            <a:endCxn id="15" idx="1"/>
          </p:cNvCxnSpPr>
          <p:nvPr/>
        </p:nvCxnSpPr>
        <p:spPr>
          <a:xfrm>
            <a:off x="1811338" y="2816773"/>
            <a:ext cx="173051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7" name="直線矢印コネクタ 46">
            <a:extLst>
              <a:ext uri="{FF2B5EF4-FFF2-40B4-BE49-F238E27FC236}">
                <a16:creationId xmlns:a16="http://schemas.microsoft.com/office/drawing/2014/main" id="{66BBAE17-0B3A-318C-B610-3A1E69FA2739}"/>
              </a:ext>
            </a:extLst>
          </p:cNvPr>
          <p:cNvCxnSpPr>
            <a:cxnSpLocks/>
          </p:cNvCxnSpPr>
          <p:nvPr/>
        </p:nvCxnSpPr>
        <p:spPr>
          <a:xfrm>
            <a:off x="1813920" y="5312872"/>
            <a:ext cx="170573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8" name="直線矢印コネクタ 47">
            <a:extLst>
              <a:ext uri="{FF2B5EF4-FFF2-40B4-BE49-F238E27FC236}">
                <a16:creationId xmlns:a16="http://schemas.microsoft.com/office/drawing/2014/main" id="{5771CEE2-142A-BFF6-E648-2083C092635E}"/>
              </a:ext>
            </a:extLst>
          </p:cNvPr>
          <p:cNvCxnSpPr>
            <a:cxnSpLocks/>
          </p:cNvCxnSpPr>
          <p:nvPr/>
        </p:nvCxnSpPr>
        <p:spPr>
          <a:xfrm>
            <a:off x="1813920" y="3864323"/>
            <a:ext cx="170573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09B12BA-1A55-876B-B80C-1CF0235E15B5}"/>
              </a:ext>
            </a:extLst>
          </p:cNvPr>
          <p:cNvSpPr txBox="1"/>
          <p:nvPr/>
        </p:nvSpPr>
        <p:spPr>
          <a:xfrm>
            <a:off x="9452263" y="6447019"/>
            <a:ext cx="3373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SUPPLEMENTARY FIGURE 1</a:t>
            </a:r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552761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5F025DF9-CFFA-445F-E577-7DE7B3D241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4585" y="314755"/>
            <a:ext cx="7182968" cy="3114245"/>
          </a:xfrm>
          <a:prstGeom prst="rect">
            <a:avLst/>
          </a:prstGeom>
        </p:spPr>
      </p:pic>
      <p:pic>
        <p:nvPicPr>
          <p:cNvPr id="5" name="図 4" descr="グラフ, 折れ線グラフ, 箱ひげ図&#10;&#10;AI 生成コンテンツは誤りを含む可能性があります。">
            <a:extLst>
              <a:ext uri="{FF2B5EF4-FFF2-40B4-BE49-F238E27FC236}">
                <a16:creationId xmlns:a16="http://schemas.microsoft.com/office/drawing/2014/main" id="{E9F1E96B-AF6D-7784-6E20-736E415949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2497" y="3699385"/>
            <a:ext cx="7005056" cy="301373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E04A2B8-C61E-CD93-6E72-6C2404A0C812}"/>
              </a:ext>
            </a:extLst>
          </p:cNvPr>
          <p:cNvSpPr txBox="1"/>
          <p:nvPr/>
        </p:nvSpPr>
        <p:spPr>
          <a:xfrm>
            <a:off x="9539953" y="6519446"/>
            <a:ext cx="30410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SUPPLEMENTARY FIGURE 2</a:t>
            </a:r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221755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1</TotalTime>
  <Words>205</Words>
  <Application>Microsoft Office PowerPoint</Application>
  <PresentationFormat>ワイド画面</PresentationFormat>
  <Paragraphs>40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村田　隆彦</dc:creator>
  <cp:lastModifiedBy>ASCA</cp:lastModifiedBy>
  <cp:revision>15</cp:revision>
  <cp:lastPrinted>2024-04-24T00:49:25Z</cp:lastPrinted>
  <dcterms:created xsi:type="dcterms:W3CDTF">2024-04-23T07:45:56Z</dcterms:created>
  <dcterms:modified xsi:type="dcterms:W3CDTF">2026-03-16T12:39:40Z</dcterms:modified>
</cp:coreProperties>
</file>